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3" r:id="rId2"/>
    <p:sldId id="262" r:id="rId3"/>
    <p:sldId id="264" r:id="rId4"/>
    <p:sldId id="268" r:id="rId5"/>
    <p:sldId id="269" r:id="rId6"/>
    <p:sldId id="265" r:id="rId7"/>
    <p:sldId id="267" r:id="rId8"/>
    <p:sldId id="266" r:id="rId9"/>
  </p:sldIdLst>
  <p:sldSz cx="1259998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1FECB4D8-DB02-4DC6-A0A2-4F2EBAE1DC90}" styleName="中間スタイル 1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351"/>
    <p:restoredTop sz="96327"/>
  </p:normalViewPr>
  <p:slideViewPr>
    <p:cSldViewPr snapToGrid="0" snapToObjects="1">
      <p:cViewPr>
        <p:scale>
          <a:sx n="83" d="100"/>
          <a:sy n="83" d="100"/>
        </p:scale>
        <p:origin x="128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ugawarakohtaroh/Desktop/&#20877;&#30330;&#24418;&#24335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ugawarakohtaroh/Desktop/&#20877;&#30330;&#24418;&#24335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C$18</c:f>
              <c:strCache>
                <c:ptCount val="1"/>
                <c:pt idx="0">
                  <c:v>abdominal or mediastinal alone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5ED-8E46-938C-464154DA7CC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5ED-8E46-938C-464154DA7CC1}"/>
              </c:ext>
            </c:extLst>
          </c:dPt>
          <c:dPt>
            <c:idx val="2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5ED-8E46-938C-464154DA7CC1}"/>
              </c:ext>
            </c:extLst>
          </c:dPt>
          <c:dPt>
            <c:idx val="3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5ED-8E46-938C-464154DA7CC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2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B$19:$B$22</c:f>
              <c:strCache>
                <c:ptCount val="4"/>
                <c:pt idx="0">
                  <c:v>dissemination</c:v>
                </c:pt>
                <c:pt idx="1">
                  <c:v>distant</c:v>
                </c:pt>
                <c:pt idx="2">
                  <c:v>distant+locoregional</c:v>
                </c:pt>
                <c:pt idx="3">
                  <c:v>locoregional alone</c:v>
                </c:pt>
              </c:strCache>
            </c:strRef>
          </c:cat>
          <c:val>
            <c:numRef>
              <c:f>Sheet1!$C$19:$C$22</c:f>
              <c:numCache>
                <c:formatCode>0_ </c:formatCode>
                <c:ptCount val="4"/>
                <c:pt idx="0">
                  <c:v>33.333333333333336</c:v>
                </c:pt>
                <c:pt idx="1">
                  <c:v>44.444444444444443</c:v>
                </c:pt>
                <c:pt idx="2">
                  <c:v>11.111111111111111</c:v>
                </c:pt>
                <c:pt idx="3">
                  <c:v>11.11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5ED-8E46-938C-464154DA7C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F$18</c:f>
              <c:strCache>
                <c:ptCount val="1"/>
                <c:pt idx="0">
                  <c:v>abdominal + mediastinal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A70-3842-B6B8-A6044FFAF3DF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A70-3842-B6B8-A6044FFAF3DF}"/>
              </c:ext>
            </c:extLst>
          </c:dPt>
          <c:dPt>
            <c:idx val="2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A70-3842-B6B8-A6044FFAF3DF}"/>
              </c:ext>
            </c:extLst>
          </c:dPt>
          <c:dPt>
            <c:idx val="3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A70-3842-B6B8-A6044FFAF3DF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8A70-3842-B6B8-A6044FFAF3DF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8A70-3842-B6B8-A6044FFAF3D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2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E$19:$E$22</c:f>
              <c:strCache>
                <c:ptCount val="4"/>
                <c:pt idx="0">
                  <c:v>dissemination</c:v>
                </c:pt>
                <c:pt idx="1">
                  <c:v>distant</c:v>
                </c:pt>
                <c:pt idx="2">
                  <c:v>distant+locoregional</c:v>
                </c:pt>
                <c:pt idx="3">
                  <c:v>locoregional alone</c:v>
                </c:pt>
              </c:strCache>
            </c:strRef>
          </c:cat>
          <c:val>
            <c:numRef>
              <c:f>Sheet1!$F$19:$F$22</c:f>
              <c:numCache>
                <c:formatCode>0_ </c:formatCode>
                <c:ptCount val="4"/>
                <c:pt idx="0">
                  <c:v>0</c:v>
                </c:pt>
                <c:pt idx="1">
                  <c:v>85.714285714285708</c:v>
                </c:pt>
                <c:pt idx="2">
                  <c:v>14.285714285714286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A70-3842-B6B8-A6044FFAF3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1472842"/>
            <a:ext cx="1070999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4726842"/>
            <a:ext cx="9449991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088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9619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479142"/>
            <a:ext cx="2716872" cy="762669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479142"/>
            <a:ext cx="7993117" cy="762669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897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0998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2243638"/>
            <a:ext cx="1086749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6022610"/>
            <a:ext cx="1086749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2933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2395710"/>
            <a:ext cx="5354995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2395710"/>
            <a:ext cx="5354995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7832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479144"/>
            <a:ext cx="10867490" cy="1739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2206137"/>
            <a:ext cx="5330385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3287331"/>
            <a:ext cx="5330385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2206137"/>
            <a:ext cx="5356636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3287331"/>
            <a:ext cx="5356636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361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4249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8634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99969"/>
            <a:ext cx="4063824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295769"/>
            <a:ext cx="6378744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699862"/>
            <a:ext cx="4063824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1770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99969"/>
            <a:ext cx="4063824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295769"/>
            <a:ext cx="6378744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699862"/>
            <a:ext cx="4063824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9794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479144"/>
            <a:ext cx="1086749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2395710"/>
            <a:ext cx="1086749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8341240"/>
            <a:ext cx="283499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11215C-39E7-7842-8EC6-F1E45F5820D2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8341240"/>
            <a:ext cx="425249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8341240"/>
            <a:ext cx="283499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74CC6-EC58-7340-BDCD-9AFF2FAF1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5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kumimoji="1"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kumimoji="1"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B248F1B-9686-8E4A-A8BE-3EE481D8D2BF}"/>
              </a:ext>
            </a:extLst>
          </p:cNvPr>
          <p:cNvSpPr txBox="1"/>
          <p:nvPr/>
        </p:nvSpPr>
        <p:spPr>
          <a:xfrm>
            <a:off x="496194" y="398842"/>
            <a:ext cx="11406503" cy="4278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600" b="1" kern="1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information</a:t>
            </a: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600" b="1" kern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altLang="ja-JP" sz="1600" kern="0" dirty="0">
                <a:latin typeface="Arial" panose="020B0604020202020204" pitchFamily="34" charset="0"/>
                <a:cs typeface="Arial" panose="020B0604020202020204" pitchFamily="34" charset="0"/>
              </a:rPr>
              <a:t>Approach used for mediastinal LN dissection</a:t>
            </a:r>
          </a:p>
          <a:p>
            <a:endParaRPr lang="en-US" altLang="ja-JP" sz="1600" kern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600" b="1" kern="100" dirty="0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Figure 2.</a:t>
            </a:r>
            <a:r>
              <a:rPr lang="en-US" altLang="ja-JP" sz="1600" kern="100" dirty="0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Survival according to tumor histology</a:t>
            </a:r>
          </a:p>
          <a:p>
            <a:endParaRPr lang="en-US" altLang="ja-JP" sz="1600" kern="100" dirty="0">
              <a:solidFill>
                <a:srgbClr val="FF0000"/>
              </a:solidFill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r>
              <a:rPr lang="en-US" altLang="ja-JP" sz="1600" b="1" kern="100" dirty="0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Figure 3.</a:t>
            </a:r>
            <a:r>
              <a:rPr lang="en-US" altLang="ja-JP" sz="1600" kern="100" dirty="0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Survival according to tumor histology and </a:t>
            </a:r>
            <a:r>
              <a:rPr lang="en-US" altLang="ja-JP" sz="1600" kern="100" dirty="0" err="1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pN</a:t>
            </a:r>
            <a:r>
              <a:rPr lang="en-US" altLang="ja-JP" sz="1600" kern="100" dirty="0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status</a:t>
            </a:r>
          </a:p>
          <a:p>
            <a:endParaRPr lang="en-US" altLang="ja-JP" sz="1600" kern="100" dirty="0">
              <a:solidFill>
                <a:srgbClr val="FF0000"/>
              </a:solidFill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r>
              <a:rPr lang="en-US" altLang="ja-JP" sz="1600" b="1" kern="100" dirty="0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Figure 4.</a:t>
            </a:r>
            <a:r>
              <a:rPr lang="en-US" altLang="ja-JP" sz="1600" kern="100" dirty="0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Recurrence pattern according to </a:t>
            </a:r>
            <a:r>
              <a:rPr lang="en-US" altLang="ja-JP" sz="1600" kern="100" dirty="0" err="1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pN</a:t>
            </a:r>
            <a:r>
              <a:rPr lang="en-US" altLang="ja-JP" sz="1600" kern="100" dirty="0">
                <a:solidFill>
                  <a:srgbClr val="FF0000"/>
                </a:solidFill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distribution</a:t>
            </a:r>
          </a:p>
          <a:p>
            <a:endParaRPr lang="en-US" altLang="ja-JP" sz="1600" kern="100" dirty="0"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r>
              <a:rPr lang="en-US" altLang="ja-JP" sz="1600" b="1" kern="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r>
              <a:rPr lang="en-US" altLang="ja-JP" sz="1600" b="1" i="0" u="none" strike="noStrike" dirty="0">
                <a:effectLst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. </a:t>
            </a:r>
            <a:r>
              <a:rPr lang="en-US" altLang="ja-JP" sz="1600" i="0" u="none" strike="noStrike" dirty="0">
                <a:effectLst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Node Zones</a:t>
            </a:r>
          </a:p>
          <a:p>
            <a:endParaRPr lang="en-US" altLang="ja-JP" sz="1600" dirty="0"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  <a:p>
            <a:r>
              <a:rPr lang="en-US" altLang="ja-JP" sz="1600" b="1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r>
              <a:rPr lang="en-US" altLang="ja-JP" sz="1600" b="1" i="0" u="none" strike="noStrike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. </a:t>
            </a:r>
            <a:r>
              <a:rPr lang="en-US" altLang="ja-JP" sz="1600" i="0" u="none" strike="noStrike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Upper and middle mediastinal LN metastases and patient characteristics</a:t>
            </a:r>
            <a:endParaRPr lang="ja-JP" altLang="en-US" sz="1600">
              <a:solidFill>
                <a:srgbClr val="FF0000"/>
              </a:solidFill>
            </a:endParaRPr>
          </a:p>
          <a:p>
            <a:endParaRPr lang="en-US" altLang="ja-JP" sz="1600" b="1" kern="100" dirty="0"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r>
              <a:rPr lang="en-US" altLang="ja-JP" sz="1600" b="1" kern="1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Table 3.</a:t>
            </a:r>
            <a:r>
              <a:rPr lang="en-US" altLang="ja-JP" sz="1600" kern="1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Recurrence pattern</a:t>
            </a:r>
            <a:endParaRPr lang="ja-JP" altLang="ja-JP" sz="1600" kern="100"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57511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図 49">
            <a:extLst>
              <a:ext uri="{FF2B5EF4-FFF2-40B4-BE49-F238E27FC236}">
                <a16:creationId xmlns:a16="http://schemas.microsoft.com/office/drawing/2014/main" id="{417F4B91-172D-4241-8F2A-B8B1FF98F13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45936" y="1181726"/>
            <a:ext cx="4114598" cy="7409877"/>
          </a:xfrm>
          <a:prstGeom prst="rect">
            <a:avLst/>
          </a:prstGeom>
        </p:spPr>
      </p:pic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AE2BDBD-5D5D-0745-BC24-DE2BCFB446EA}"/>
              </a:ext>
            </a:extLst>
          </p:cNvPr>
          <p:cNvSpPr txBox="1"/>
          <p:nvPr/>
        </p:nvSpPr>
        <p:spPr>
          <a:xfrm>
            <a:off x="783020" y="2234977"/>
            <a:ext cx="2462916" cy="3693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Right Neck Incision</a:t>
            </a:r>
            <a:endParaRPr kumimoji="1" lang="ja-JP" altLang="en-US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8C212D93-A7F6-904B-9851-4E2FA03411E6}"/>
              </a:ext>
            </a:extLst>
          </p:cNvPr>
          <p:cNvSpPr txBox="1"/>
          <p:nvPr/>
        </p:nvSpPr>
        <p:spPr>
          <a:xfrm>
            <a:off x="7113871" y="2650786"/>
            <a:ext cx="2018501" cy="923330"/>
          </a:xfrm>
          <a:prstGeom prst="rect">
            <a:avLst/>
          </a:prstGeom>
          <a:noFill/>
          <a:ln w="28575">
            <a:solidFill>
              <a:schemeClr val="accent6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ranscervical</a:t>
            </a:r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</a:p>
          <a:p>
            <a:r>
              <a:rPr kumimoji="1" lang="en-US" altLang="ja-JP" dirty="0" err="1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Mediastinoscopic</a:t>
            </a:r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</a:p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pproach</a:t>
            </a:r>
            <a:endParaRPr kumimoji="1" lang="ja-JP" altLang="en-US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3" name="楕円 9">
            <a:extLst>
              <a:ext uri="{FF2B5EF4-FFF2-40B4-BE49-F238E27FC236}">
                <a16:creationId xmlns:a16="http://schemas.microsoft.com/office/drawing/2014/main" id="{04C04CB6-D2DA-6349-9224-4698B89D2ECE}"/>
              </a:ext>
            </a:extLst>
          </p:cNvPr>
          <p:cNvSpPr/>
          <p:nvPr/>
        </p:nvSpPr>
        <p:spPr>
          <a:xfrm>
            <a:off x="4485274" y="3228513"/>
            <a:ext cx="1128545" cy="2531173"/>
          </a:xfrm>
          <a:prstGeom prst="ellipse">
            <a:avLst/>
          </a:prstGeom>
          <a:noFill/>
          <a:ln w="28575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4" name="楕円 10">
            <a:extLst>
              <a:ext uri="{FF2B5EF4-FFF2-40B4-BE49-F238E27FC236}">
                <a16:creationId xmlns:a16="http://schemas.microsoft.com/office/drawing/2014/main" id="{24865A31-A6D1-B241-980D-873A5E34B4FA}"/>
              </a:ext>
            </a:extLst>
          </p:cNvPr>
          <p:cNvSpPr/>
          <p:nvPr/>
        </p:nvSpPr>
        <p:spPr>
          <a:xfrm rot="20547687">
            <a:off x="4802039" y="5125079"/>
            <a:ext cx="831097" cy="1229031"/>
          </a:xfrm>
          <a:prstGeom prst="ellipse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5" name="楕円 15">
            <a:extLst>
              <a:ext uri="{FF2B5EF4-FFF2-40B4-BE49-F238E27FC236}">
                <a16:creationId xmlns:a16="http://schemas.microsoft.com/office/drawing/2014/main" id="{DDD70786-386F-5846-8798-068005F21B8A}"/>
              </a:ext>
            </a:extLst>
          </p:cNvPr>
          <p:cNvSpPr/>
          <p:nvPr/>
        </p:nvSpPr>
        <p:spPr>
          <a:xfrm>
            <a:off x="4857253" y="2118282"/>
            <a:ext cx="706748" cy="1455834"/>
          </a:xfrm>
          <a:prstGeom prst="ellipse">
            <a:avLst/>
          </a:prstGeom>
          <a:noFill/>
          <a:ln w="28575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id="{F6B82ECA-83BF-FB43-ACBE-B411CA42499F}"/>
              </a:ext>
            </a:extLst>
          </p:cNvPr>
          <p:cNvCxnSpPr>
            <a:cxnSpLocks/>
            <a:stCxn id="55" idx="6"/>
            <a:endCxn id="52" idx="1"/>
          </p:cNvCxnSpPr>
          <p:nvPr/>
        </p:nvCxnSpPr>
        <p:spPr>
          <a:xfrm>
            <a:off x="5564001" y="2846199"/>
            <a:ext cx="1549870" cy="266252"/>
          </a:xfrm>
          <a:prstGeom prst="straightConnector1">
            <a:avLst/>
          </a:prstGeom>
          <a:ln w="28575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041C3AE-DE9A-9B40-9C2B-B14162E89AED}"/>
              </a:ext>
            </a:extLst>
          </p:cNvPr>
          <p:cNvSpPr txBox="1"/>
          <p:nvPr/>
        </p:nvSpPr>
        <p:spPr>
          <a:xfrm>
            <a:off x="7025714" y="4061083"/>
            <a:ext cx="2390398" cy="923330"/>
          </a:xfrm>
          <a:prstGeom prst="rect">
            <a:avLst/>
          </a:prstGeom>
          <a:noFill/>
          <a:ln w="28575">
            <a:solidFill>
              <a:schemeClr val="accent2">
                <a:lumMod val="60000"/>
                <a:lumOff val="4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ranshiatal</a:t>
            </a:r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</a:p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Robotic/laparoscopic </a:t>
            </a:r>
          </a:p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pproach</a:t>
            </a:r>
            <a:endParaRPr kumimoji="1" lang="ja-JP" altLang="en-US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BA95C633-D3F0-F249-830A-69CA0D27EB49}"/>
              </a:ext>
            </a:extLst>
          </p:cNvPr>
          <p:cNvCxnSpPr>
            <a:cxnSpLocks/>
          </p:cNvCxnSpPr>
          <p:nvPr/>
        </p:nvCxnSpPr>
        <p:spPr>
          <a:xfrm flipV="1">
            <a:off x="5631112" y="4557993"/>
            <a:ext cx="1313205" cy="114744"/>
          </a:xfrm>
          <a:prstGeom prst="straightConnector1">
            <a:avLst/>
          </a:prstGeom>
          <a:ln w="28575">
            <a:solidFill>
              <a:schemeClr val="accent2">
                <a:lumMod val="60000"/>
                <a:lumOff val="4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DF356983-A803-9543-A4E7-E90FFF54174E}"/>
              </a:ext>
            </a:extLst>
          </p:cNvPr>
          <p:cNvSpPr txBox="1"/>
          <p:nvPr/>
        </p:nvSpPr>
        <p:spPr>
          <a:xfrm>
            <a:off x="7244759" y="6615397"/>
            <a:ext cx="1620957" cy="92333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ranshiatal</a:t>
            </a:r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</a:p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Laparoscopic </a:t>
            </a:r>
          </a:p>
          <a:p>
            <a:r>
              <a:rPr kumimoji="1" lang="en-US" altLang="ja-JP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pproach</a:t>
            </a:r>
            <a:endParaRPr kumimoji="1" lang="ja-JP" altLang="en-US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0" name="直線矢印コネクタ 59">
            <a:extLst>
              <a:ext uri="{FF2B5EF4-FFF2-40B4-BE49-F238E27FC236}">
                <a16:creationId xmlns:a16="http://schemas.microsoft.com/office/drawing/2014/main" id="{9549B090-1CA7-1043-BA58-5CE2C4CB5B03}"/>
              </a:ext>
            </a:extLst>
          </p:cNvPr>
          <p:cNvCxnSpPr>
            <a:cxnSpLocks/>
            <a:stCxn id="54" idx="6"/>
          </p:cNvCxnSpPr>
          <p:nvPr/>
        </p:nvCxnSpPr>
        <p:spPr>
          <a:xfrm>
            <a:off x="5613819" y="5614371"/>
            <a:ext cx="1572465" cy="1132892"/>
          </a:xfrm>
          <a:prstGeom prst="straightConnector1">
            <a:avLst/>
          </a:prstGeom>
          <a:ln w="2857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" name="図 60">
            <a:extLst>
              <a:ext uri="{FF2B5EF4-FFF2-40B4-BE49-F238E27FC236}">
                <a16:creationId xmlns:a16="http://schemas.microsoft.com/office/drawing/2014/main" id="{7EAC89FD-C44E-D942-8419-2773796EA8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079" r="11398"/>
          <a:stretch/>
        </p:blipFill>
        <p:spPr>
          <a:xfrm rot="11533504">
            <a:off x="5959667" y="647482"/>
            <a:ext cx="1855413" cy="1707669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FA5405B3-5BCC-E74D-896E-AC378B6933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1755" y="3446563"/>
            <a:ext cx="3285381" cy="3725594"/>
          </a:xfrm>
          <a:prstGeom prst="rect">
            <a:avLst/>
          </a:prstGeom>
        </p:spPr>
      </p:pic>
      <p:cxnSp>
        <p:nvCxnSpPr>
          <p:cNvPr id="63" name="直線矢印コネクタ 62">
            <a:extLst>
              <a:ext uri="{FF2B5EF4-FFF2-40B4-BE49-F238E27FC236}">
                <a16:creationId xmlns:a16="http://schemas.microsoft.com/office/drawing/2014/main" id="{1F2FBDC7-6330-1040-AE79-5C98DD3FF3A9}"/>
              </a:ext>
            </a:extLst>
          </p:cNvPr>
          <p:cNvCxnSpPr>
            <a:cxnSpLocks/>
            <a:stCxn id="72" idx="2"/>
            <a:endCxn id="51" idx="3"/>
          </p:cNvCxnSpPr>
          <p:nvPr/>
        </p:nvCxnSpPr>
        <p:spPr>
          <a:xfrm flipH="1" flipV="1">
            <a:off x="3245936" y="2419643"/>
            <a:ext cx="1182186" cy="455383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楕円 48">
            <a:extLst>
              <a:ext uri="{FF2B5EF4-FFF2-40B4-BE49-F238E27FC236}">
                <a16:creationId xmlns:a16="http://schemas.microsoft.com/office/drawing/2014/main" id="{C9A5F8FE-E9D9-774A-903F-E645E796E326}"/>
              </a:ext>
            </a:extLst>
          </p:cNvPr>
          <p:cNvSpPr/>
          <p:nvPr/>
        </p:nvSpPr>
        <p:spPr>
          <a:xfrm rot="2053691">
            <a:off x="4755587" y="6004231"/>
            <a:ext cx="831097" cy="1420242"/>
          </a:xfrm>
          <a:prstGeom prst="ellipse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6" name="直線矢印コネクタ 65">
            <a:extLst>
              <a:ext uri="{FF2B5EF4-FFF2-40B4-BE49-F238E27FC236}">
                <a16:creationId xmlns:a16="http://schemas.microsoft.com/office/drawing/2014/main" id="{C3C08F91-DFF6-D841-B2C4-EB15FD5312F3}"/>
              </a:ext>
            </a:extLst>
          </p:cNvPr>
          <p:cNvCxnSpPr>
            <a:cxnSpLocks/>
            <a:stCxn id="65" idx="6"/>
          </p:cNvCxnSpPr>
          <p:nvPr/>
        </p:nvCxnSpPr>
        <p:spPr>
          <a:xfrm flipV="1">
            <a:off x="5514713" y="6747263"/>
            <a:ext cx="1671571" cy="200831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E7287264-925C-D74A-A417-80C49A0536FC}"/>
              </a:ext>
            </a:extLst>
          </p:cNvPr>
          <p:cNvSpPr txBox="1"/>
          <p:nvPr/>
        </p:nvSpPr>
        <p:spPr>
          <a:xfrm>
            <a:off x="467419" y="2631454"/>
            <a:ext cx="3262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ight recurrent laryngea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 nerve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5B4E54E0-8702-5047-BFEC-9133708B85B6}"/>
              </a:ext>
            </a:extLst>
          </p:cNvPr>
          <p:cNvSpPr txBox="1"/>
          <p:nvPr/>
        </p:nvSpPr>
        <p:spPr>
          <a:xfrm>
            <a:off x="9132372" y="2760309"/>
            <a:ext cx="34676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recurrent laryngea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 nerve</a:t>
            </a:r>
          </a:p>
          <a:p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pper thoracic </a:t>
            </a:r>
            <a:r>
              <a:rPr lang="en-US" altLang="ja-JP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raesophageal</a:t>
            </a:r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2B83D7CE-3C0A-FC44-8506-5521E8ED5CCB}"/>
              </a:ext>
            </a:extLst>
          </p:cNvPr>
          <p:cNvSpPr txBox="1"/>
          <p:nvPr/>
        </p:nvSpPr>
        <p:spPr>
          <a:xfrm>
            <a:off x="9067955" y="5019394"/>
            <a:ext cx="3467616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bcarinal</a:t>
            </a:r>
          </a:p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oracic </a:t>
            </a:r>
            <a:r>
              <a:rPr lang="en-US" altLang="ja-JP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raesophageal</a:t>
            </a:r>
            <a:endParaRPr lang="en-US" altLang="ja-JP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wer thoracic </a:t>
            </a:r>
            <a:r>
              <a:rPr lang="en-US" altLang="ja-JP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raesophageal</a:t>
            </a:r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radiaphragmatic</a:t>
            </a:r>
          </a:p>
          <a:p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terior mediastinal </a:t>
            </a: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DAF893F2-0CA4-4642-BEC0-3850D8D82E0E}"/>
              </a:ext>
            </a:extLst>
          </p:cNvPr>
          <p:cNvSpPr txBox="1"/>
          <p:nvPr/>
        </p:nvSpPr>
        <p:spPr>
          <a:xfrm>
            <a:off x="7566880" y="7556951"/>
            <a:ext cx="3403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bdominal (</a:t>
            </a:r>
            <a:r>
              <a:rPr lang="en-US" altLang="ja-JP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erigastric</a:t>
            </a:r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celiac</a:t>
            </a:r>
            <a:r>
              <a:rPr lang="en-US" altLang="ja-JP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2" name="楕円 15">
            <a:extLst>
              <a:ext uri="{FF2B5EF4-FFF2-40B4-BE49-F238E27FC236}">
                <a16:creationId xmlns:a16="http://schemas.microsoft.com/office/drawing/2014/main" id="{4CE9A50B-44EF-3244-85E0-C0CB29CD90C6}"/>
              </a:ext>
            </a:extLst>
          </p:cNvPr>
          <p:cNvSpPr/>
          <p:nvPr/>
        </p:nvSpPr>
        <p:spPr>
          <a:xfrm>
            <a:off x="4428122" y="2303489"/>
            <a:ext cx="521568" cy="1143074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0000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617CD649-4F6F-F244-B0E6-3A7E8A14B0DD}"/>
              </a:ext>
            </a:extLst>
          </p:cNvPr>
          <p:cNvSpPr txBox="1"/>
          <p:nvPr/>
        </p:nvSpPr>
        <p:spPr>
          <a:xfrm>
            <a:off x="164620" y="193436"/>
            <a:ext cx="2842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ja-JP" altLang="en-US"/>
          </a:p>
        </p:txBody>
      </p: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DBB9D98D-2EF1-054C-83AF-B2A900050EAB}"/>
              </a:ext>
            </a:extLst>
          </p:cNvPr>
          <p:cNvGrpSpPr/>
          <p:nvPr/>
        </p:nvGrpSpPr>
        <p:grpSpPr>
          <a:xfrm>
            <a:off x="2477371" y="4701777"/>
            <a:ext cx="196401" cy="137157"/>
            <a:chOff x="2473325" y="4697731"/>
            <a:chExt cx="196401" cy="137157"/>
          </a:xfrm>
        </p:grpSpPr>
        <p:pic>
          <p:nvPicPr>
            <p:cNvPr id="32" name="図 31">
              <a:extLst>
                <a:ext uri="{FF2B5EF4-FFF2-40B4-BE49-F238E27FC236}">
                  <a16:creationId xmlns:a16="http://schemas.microsoft.com/office/drawing/2014/main" id="{45AB77E5-5D30-6D4A-BECE-C08B295022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6099" t="36311" r="39082" b="62462"/>
            <a:stretch/>
          </p:blipFill>
          <p:spPr>
            <a:xfrm>
              <a:off x="2511426" y="4697731"/>
              <a:ext cx="158300" cy="45719"/>
            </a:xfrm>
            <a:prstGeom prst="rect">
              <a:avLst/>
            </a:prstGeom>
          </p:spPr>
        </p:pic>
        <p:pic>
          <p:nvPicPr>
            <p:cNvPr id="33" name="図 32">
              <a:extLst>
                <a:ext uri="{FF2B5EF4-FFF2-40B4-BE49-F238E27FC236}">
                  <a16:creationId xmlns:a16="http://schemas.microsoft.com/office/drawing/2014/main" id="{86E415F2-8797-0C44-A24B-A5FD5CF2FA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6099" t="36311" r="39082" b="62462"/>
            <a:stretch/>
          </p:blipFill>
          <p:spPr>
            <a:xfrm>
              <a:off x="2511426" y="4743450"/>
              <a:ext cx="158300" cy="45719"/>
            </a:xfrm>
            <a:prstGeom prst="rect">
              <a:avLst/>
            </a:prstGeom>
          </p:spPr>
        </p:pic>
        <p:pic>
          <p:nvPicPr>
            <p:cNvPr id="34" name="図 33">
              <a:extLst>
                <a:ext uri="{FF2B5EF4-FFF2-40B4-BE49-F238E27FC236}">
                  <a16:creationId xmlns:a16="http://schemas.microsoft.com/office/drawing/2014/main" id="{774B60D2-BE94-9842-BD01-055C9E8A4D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6099" t="36311" r="39082" b="62462"/>
            <a:stretch/>
          </p:blipFill>
          <p:spPr>
            <a:xfrm>
              <a:off x="2473325" y="4789169"/>
              <a:ext cx="158300" cy="4571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901091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0A4792C-E493-4348-BEEF-F200CA1B00C5}"/>
              </a:ext>
            </a:extLst>
          </p:cNvPr>
          <p:cNvSpPr txBox="1"/>
          <p:nvPr/>
        </p:nvSpPr>
        <p:spPr>
          <a:xfrm>
            <a:off x="164620" y="193436"/>
            <a:ext cx="2842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ja-JP" altLang="en-US">
              <a:solidFill>
                <a:srgbClr val="FF0000"/>
              </a:solidFill>
            </a:endParaRPr>
          </a:p>
        </p:txBody>
      </p:sp>
      <p:pic>
        <p:nvPicPr>
          <p:cNvPr id="57" name="図 56">
            <a:extLst>
              <a:ext uri="{FF2B5EF4-FFF2-40B4-BE49-F238E27FC236}">
                <a16:creationId xmlns:a16="http://schemas.microsoft.com/office/drawing/2014/main" id="{EE79C46C-E311-8B4F-9FA3-5711AF036D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777" t="2139" r="4215" b="14661"/>
          <a:stretch/>
        </p:blipFill>
        <p:spPr>
          <a:xfrm>
            <a:off x="7138477" y="1036722"/>
            <a:ext cx="4196688" cy="4196688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E647790E-5390-8C4B-980D-70CCAD62A3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540" t="1859" r="3606" b="14308"/>
          <a:stretch/>
        </p:blipFill>
        <p:spPr>
          <a:xfrm>
            <a:off x="1533047" y="1036722"/>
            <a:ext cx="4162706" cy="4203012"/>
          </a:xfrm>
          <a:prstGeom prst="rect">
            <a:avLst/>
          </a:prstGeom>
        </p:spPr>
      </p:pic>
      <p:grpSp>
        <p:nvGrpSpPr>
          <p:cNvPr id="59" name="図形グループ 6">
            <a:extLst>
              <a:ext uri="{FF2B5EF4-FFF2-40B4-BE49-F238E27FC236}">
                <a16:creationId xmlns:a16="http://schemas.microsoft.com/office/drawing/2014/main" id="{1612CDE3-DAC1-3C43-B8FF-61B1C81F4F0F}"/>
              </a:ext>
            </a:extLst>
          </p:cNvPr>
          <p:cNvGrpSpPr/>
          <p:nvPr/>
        </p:nvGrpSpPr>
        <p:grpSpPr>
          <a:xfrm>
            <a:off x="1402768" y="4654950"/>
            <a:ext cx="5073823" cy="1189670"/>
            <a:chOff x="3856560" y="2897809"/>
            <a:chExt cx="4388548" cy="1016453"/>
          </a:xfrm>
        </p:grpSpPr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F18747F0-0048-DB49-BA98-72B78E5D5208}"/>
                </a:ext>
              </a:extLst>
            </p:cNvPr>
            <p:cNvSpPr txBox="1"/>
            <p:nvPr/>
          </p:nvSpPr>
          <p:spPr>
            <a:xfrm>
              <a:off x="5074956" y="3625002"/>
              <a:ext cx="1654705" cy="289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Years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 after surgery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0560C14B-C1D3-3642-B493-554FB108BDC4}"/>
                </a:ext>
              </a:extLst>
            </p:cNvPr>
            <p:cNvSpPr txBox="1"/>
            <p:nvPr/>
          </p:nvSpPr>
          <p:spPr>
            <a:xfrm>
              <a:off x="3856560" y="3409294"/>
              <a:ext cx="4388548" cy="2563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1                    2                    3                   4</a:t>
              </a:r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A8327563-B8A0-5E47-ACB6-79B9A7BDAA4B}"/>
                </a:ext>
              </a:extLst>
            </p:cNvPr>
            <p:cNvSpPr/>
            <p:nvPr/>
          </p:nvSpPr>
          <p:spPr>
            <a:xfrm>
              <a:off x="4076630" y="2897809"/>
              <a:ext cx="2366551" cy="28926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Overall</a:t>
              </a:r>
              <a:r>
                <a:rPr lang="ja-JP" altLang="en-US" sz="160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Survival</a:t>
              </a:r>
              <a:endParaRPr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5817B52D-C7EE-2241-B0EB-6C9D5BFA100B}"/>
              </a:ext>
            </a:extLst>
          </p:cNvPr>
          <p:cNvSpPr txBox="1"/>
          <p:nvPr/>
        </p:nvSpPr>
        <p:spPr>
          <a:xfrm>
            <a:off x="619394" y="91513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[a]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EED8B91D-E8D5-6E41-804C-2CE2B3157C82}"/>
              </a:ext>
            </a:extLst>
          </p:cNvPr>
          <p:cNvSpPr txBox="1"/>
          <p:nvPr/>
        </p:nvSpPr>
        <p:spPr>
          <a:xfrm>
            <a:off x="6303207" y="91683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[b]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6F60DD0F-D05A-C64E-B147-E638CA711518}"/>
              </a:ext>
            </a:extLst>
          </p:cNvPr>
          <p:cNvSpPr txBox="1"/>
          <p:nvPr/>
        </p:nvSpPr>
        <p:spPr>
          <a:xfrm>
            <a:off x="779100" y="915133"/>
            <a:ext cx="745871" cy="4832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  <a:p>
            <a:pPr algn="r"/>
            <a:endParaRPr kumimoji="1"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B6C3F867-4198-CB4F-AB29-B6031A7E31C7}"/>
              </a:ext>
            </a:extLst>
          </p:cNvPr>
          <p:cNvSpPr/>
          <p:nvPr/>
        </p:nvSpPr>
        <p:spPr>
          <a:xfrm>
            <a:off x="7506552" y="4648611"/>
            <a:ext cx="313045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isease-free survival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図形グループ 6">
            <a:extLst>
              <a:ext uri="{FF2B5EF4-FFF2-40B4-BE49-F238E27FC236}">
                <a16:creationId xmlns:a16="http://schemas.microsoft.com/office/drawing/2014/main" id="{39EB44F7-12EF-8B4E-A372-71C3174F24B5}"/>
              </a:ext>
            </a:extLst>
          </p:cNvPr>
          <p:cNvGrpSpPr/>
          <p:nvPr/>
        </p:nvGrpSpPr>
        <p:grpSpPr>
          <a:xfrm>
            <a:off x="7046689" y="5253597"/>
            <a:ext cx="5073823" cy="591021"/>
            <a:chOff x="3856560" y="3409294"/>
            <a:chExt cx="4388548" cy="504968"/>
          </a:xfrm>
        </p:grpSpPr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17905524-42F5-254C-B30C-67D7661BA5A6}"/>
                </a:ext>
              </a:extLst>
            </p:cNvPr>
            <p:cNvSpPr txBox="1"/>
            <p:nvPr/>
          </p:nvSpPr>
          <p:spPr>
            <a:xfrm>
              <a:off x="5071261" y="3625002"/>
              <a:ext cx="1654705" cy="289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Years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 after surgery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FEA2F8F3-AD56-FB4D-BFAB-4957796A4383}"/>
                </a:ext>
              </a:extLst>
            </p:cNvPr>
            <p:cNvSpPr txBox="1"/>
            <p:nvPr/>
          </p:nvSpPr>
          <p:spPr>
            <a:xfrm>
              <a:off x="3856560" y="3409294"/>
              <a:ext cx="4388548" cy="2563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1                    2                    3                   4</a:t>
              </a:r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1D36B005-D866-A449-BBA4-40FBB94551D0}"/>
              </a:ext>
            </a:extLst>
          </p:cNvPr>
          <p:cNvSpPr txBox="1"/>
          <p:nvPr/>
        </p:nvSpPr>
        <p:spPr>
          <a:xfrm>
            <a:off x="6423021" y="915133"/>
            <a:ext cx="745871" cy="4832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kumimoji="1"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ja-JP" sz="13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  <a:p>
            <a:pPr algn="r"/>
            <a:endParaRPr kumimoji="1"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1" name="表 3">
            <a:extLst>
              <a:ext uri="{FF2B5EF4-FFF2-40B4-BE49-F238E27FC236}">
                <a16:creationId xmlns:a16="http://schemas.microsoft.com/office/drawing/2014/main" id="{39950643-497C-4B47-9581-2E0BEFC36C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6945538"/>
              </p:ext>
            </p:extLst>
          </p:nvPr>
        </p:nvGraphicFramePr>
        <p:xfrm>
          <a:off x="544972" y="6027776"/>
          <a:ext cx="5661148" cy="487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45053">
                  <a:extLst>
                    <a:ext uri="{9D8B030D-6E8A-4147-A177-3AD203B41FA5}">
                      <a16:colId xmlns:a16="http://schemas.microsoft.com/office/drawing/2014/main" val="2840817046"/>
                    </a:ext>
                  </a:extLst>
                </a:gridCol>
                <a:gridCol w="1043219">
                  <a:extLst>
                    <a:ext uri="{9D8B030D-6E8A-4147-A177-3AD203B41FA5}">
                      <a16:colId xmlns:a16="http://schemas.microsoft.com/office/drawing/2014/main" val="2877216489"/>
                    </a:ext>
                  </a:extLst>
                </a:gridCol>
                <a:gridCol w="1043219">
                  <a:extLst>
                    <a:ext uri="{9D8B030D-6E8A-4147-A177-3AD203B41FA5}">
                      <a16:colId xmlns:a16="http://schemas.microsoft.com/office/drawing/2014/main" val="523949689"/>
                    </a:ext>
                  </a:extLst>
                </a:gridCol>
                <a:gridCol w="1043219">
                  <a:extLst>
                    <a:ext uri="{9D8B030D-6E8A-4147-A177-3AD203B41FA5}">
                      <a16:colId xmlns:a16="http://schemas.microsoft.com/office/drawing/2014/main" val="845289824"/>
                    </a:ext>
                  </a:extLst>
                </a:gridCol>
                <a:gridCol w="1043219">
                  <a:extLst>
                    <a:ext uri="{9D8B030D-6E8A-4147-A177-3AD203B41FA5}">
                      <a16:colId xmlns:a16="http://schemas.microsoft.com/office/drawing/2014/main" val="3198899078"/>
                    </a:ext>
                  </a:extLst>
                </a:gridCol>
                <a:gridCol w="1043219">
                  <a:extLst>
                    <a:ext uri="{9D8B030D-6E8A-4147-A177-3AD203B41FA5}">
                      <a16:colId xmlns:a16="http://schemas.microsoft.com/office/drawing/2014/main" val="1896274380"/>
                    </a:ext>
                  </a:extLst>
                </a:gridCol>
              </a:tblGrid>
              <a:tr h="243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C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27919612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A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39426906"/>
                  </a:ext>
                </a:extLst>
              </a:tr>
            </a:tbl>
          </a:graphicData>
        </a:graphic>
      </p:graphicFrame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D4F0EA6E-3B44-AC45-9957-69BA2884D422}"/>
              </a:ext>
            </a:extLst>
          </p:cNvPr>
          <p:cNvSpPr txBox="1"/>
          <p:nvPr/>
        </p:nvSpPr>
        <p:spPr>
          <a:xfrm>
            <a:off x="887763" y="5622931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E1316EB3-1428-C34C-A3C1-5FB5C0E0EB71}"/>
              </a:ext>
            </a:extLst>
          </p:cNvPr>
          <p:cNvSpPr txBox="1"/>
          <p:nvPr/>
        </p:nvSpPr>
        <p:spPr>
          <a:xfrm>
            <a:off x="6491101" y="5622931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4" name="表 3">
            <a:extLst>
              <a:ext uri="{FF2B5EF4-FFF2-40B4-BE49-F238E27FC236}">
                <a16:creationId xmlns:a16="http://schemas.microsoft.com/office/drawing/2014/main" id="{B92DFA1A-5985-5B4D-9750-84CE51A6E4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9665411"/>
              </p:ext>
            </p:extLst>
          </p:nvPr>
        </p:nvGraphicFramePr>
        <p:xfrm>
          <a:off x="6337958" y="6019879"/>
          <a:ext cx="5563892" cy="487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37407">
                  <a:extLst>
                    <a:ext uri="{9D8B030D-6E8A-4147-A177-3AD203B41FA5}">
                      <a16:colId xmlns:a16="http://schemas.microsoft.com/office/drawing/2014/main" val="2840817046"/>
                    </a:ext>
                  </a:extLst>
                </a:gridCol>
                <a:gridCol w="1025297">
                  <a:extLst>
                    <a:ext uri="{9D8B030D-6E8A-4147-A177-3AD203B41FA5}">
                      <a16:colId xmlns:a16="http://schemas.microsoft.com/office/drawing/2014/main" val="2877216489"/>
                    </a:ext>
                  </a:extLst>
                </a:gridCol>
                <a:gridCol w="1025297">
                  <a:extLst>
                    <a:ext uri="{9D8B030D-6E8A-4147-A177-3AD203B41FA5}">
                      <a16:colId xmlns:a16="http://schemas.microsoft.com/office/drawing/2014/main" val="523949689"/>
                    </a:ext>
                  </a:extLst>
                </a:gridCol>
                <a:gridCol w="1025297">
                  <a:extLst>
                    <a:ext uri="{9D8B030D-6E8A-4147-A177-3AD203B41FA5}">
                      <a16:colId xmlns:a16="http://schemas.microsoft.com/office/drawing/2014/main" val="845289824"/>
                    </a:ext>
                  </a:extLst>
                </a:gridCol>
                <a:gridCol w="1025297">
                  <a:extLst>
                    <a:ext uri="{9D8B030D-6E8A-4147-A177-3AD203B41FA5}">
                      <a16:colId xmlns:a16="http://schemas.microsoft.com/office/drawing/2014/main" val="3198899078"/>
                    </a:ext>
                  </a:extLst>
                </a:gridCol>
                <a:gridCol w="1025297">
                  <a:extLst>
                    <a:ext uri="{9D8B030D-6E8A-4147-A177-3AD203B41FA5}">
                      <a16:colId xmlns:a16="http://schemas.microsoft.com/office/drawing/2014/main" val="1896274380"/>
                    </a:ext>
                  </a:extLst>
                </a:gridCol>
              </a:tblGrid>
              <a:tr h="243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C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27919612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A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39426906"/>
                  </a:ext>
                </a:extLst>
              </a:tr>
            </a:tbl>
          </a:graphicData>
        </a:graphic>
      </p:graphicFrame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F4B06A0E-0219-684D-86BB-2C6691E91661}"/>
              </a:ext>
            </a:extLst>
          </p:cNvPr>
          <p:cNvSpPr txBox="1"/>
          <p:nvPr/>
        </p:nvSpPr>
        <p:spPr>
          <a:xfrm>
            <a:off x="4724505" y="1606873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C</a:t>
            </a:r>
            <a:endParaRPr kumimoji="1" lang="ja-JP" altLang="en-US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C99C0D80-80B1-E348-B12D-3A099FCA46CE}"/>
              </a:ext>
            </a:extLst>
          </p:cNvPr>
          <p:cNvSpPr txBox="1"/>
          <p:nvPr/>
        </p:nvSpPr>
        <p:spPr>
          <a:xfrm>
            <a:off x="4729686" y="2593422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  <a:endParaRPr kumimoji="1" lang="ja-JP" altLang="en-US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DBF7AB24-7A60-2346-80AD-014487BA3F9D}"/>
              </a:ext>
            </a:extLst>
          </p:cNvPr>
          <p:cNvSpPr txBox="1"/>
          <p:nvPr/>
        </p:nvSpPr>
        <p:spPr>
          <a:xfrm>
            <a:off x="4616410" y="4758034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43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88C679DE-C1D6-5B4E-B355-17EDF9EA485C}"/>
              </a:ext>
            </a:extLst>
          </p:cNvPr>
          <p:cNvSpPr txBox="1"/>
          <p:nvPr/>
        </p:nvSpPr>
        <p:spPr>
          <a:xfrm>
            <a:off x="10509838" y="1819528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C</a:t>
            </a:r>
            <a:endParaRPr kumimoji="1" lang="ja-JP" altLang="en-US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164BBA60-4D0F-1D43-A4B7-BF0100C5B59D}"/>
              </a:ext>
            </a:extLst>
          </p:cNvPr>
          <p:cNvSpPr txBox="1"/>
          <p:nvPr/>
        </p:nvSpPr>
        <p:spPr>
          <a:xfrm>
            <a:off x="10509838" y="3367517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  <a:endParaRPr kumimoji="1" lang="ja-JP" altLang="en-US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AAF1BBF2-21BB-374F-947C-FF7B977C8418}"/>
              </a:ext>
            </a:extLst>
          </p:cNvPr>
          <p:cNvSpPr txBox="1"/>
          <p:nvPr/>
        </p:nvSpPr>
        <p:spPr>
          <a:xfrm>
            <a:off x="10401743" y="4758034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28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47368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0A4792C-E493-4348-BEEF-F200CA1B00C5}"/>
              </a:ext>
            </a:extLst>
          </p:cNvPr>
          <p:cNvSpPr txBox="1"/>
          <p:nvPr/>
        </p:nvSpPr>
        <p:spPr>
          <a:xfrm>
            <a:off x="164620" y="193436"/>
            <a:ext cx="2842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ja-JP" altLang="en-US">
              <a:solidFill>
                <a:srgbClr val="FF0000"/>
              </a:solidFill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6BEB2C01-9A2F-D04D-86A4-EAA694FF62EB}"/>
              </a:ext>
            </a:extLst>
          </p:cNvPr>
          <p:cNvSpPr txBox="1"/>
          <p:nvPr/>
        </p:nvSpPr>
        <p:spPr>
          <a:xfrm>
            <a:off x="164620" y="1965332"/>
            <a:ext cx="307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760992CF-F38C-F44B-B936-499B47DE4920}"/>
              </a:ext>
            </a:extLst>
          </p:cNvPr>
          <p:cNvGrpSpPr>
            <a:grpSpLocks noChangeAspect="1"/>
          </p:cNvGrpSpPr>
          <p:nvPr/>
        </p:nvGrpSpPr>
        <p:grpSpPr>
          <a:xfrm>
            <a:off x="3262732" y="390603"/>
            <a:ext cx="4839178" cy="4186870"/>
            <a:chOff x="2848154" y="644279"/>
            <a:chExt cx="5697491" cy="4929485"/>
          </a:xfrm>
        </p:grpSpPr>
        <p:pic>
          <p:nvPicPr>
            <p:cNvPr id="105" name="図 104">
              <a:extLst>
                <a:ext uri="{FF2B5EF4-FFF2-40B4-BE49-F238E27FC236}">
                  <a16:creationId xmlns:a16="http://schemas.microsoft.com/office/drawing/2014/main" id="{0A7ADC7F-B409-234B-A3D8-336B8FC04C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1433" t="2205" r="4063" b="15056"/>
            <a:stretch/>
          </p:blipFill>
          <p:spPr>
            <a:xfrm>
              <a:off x="3577481" y="776020"/>
              <a:ext cx="4209165" cy="4214239"/>
            </a:xfrm>
            <a:prstGeom prst="rect">
              <a:avLst/>
            </a:prstGeom>
          </p:spPr>
        </p:pic>
        <p:grpSp>
          <p:nvGrpSpPr>
            <p:cNvPr id="106" name="グループ化 105">
              <a:extLst>
                <a:ext uri="{FF2B5EF4-FFF2-40B4-BE49-F238E27FC236}">
                  <a16:creationId xmlns:a16="http://schemas.microsoft.com/office/drawing/2014/main" id="{8B33C2F7-1125-1F43-AE42-837681B58EAC}"/>
                </a:ext>
              </a:extLst>
            </p:cNvPr>
            <p:cNvGrpSpPr/>
            <p:nvPr/>
          </p:nvGrpSpPr>
          <p:grpSpPr>
            <a:xfrm>
              <a:off x="2848154" y="644279"/>
              <a:ext cx="4799385" cy="4929485"/>
              <a:chOff x="6333307" y="1591300"/>
              <a:chExt cx="4799385" cy="4929485"/>
            </a:xfrm>
          </p:grpSpPr>
          <p:sp>
            <p:nvSpPr>
              <p:cNvPr id="108" name="テキスト ボックス 107">
                <a:extLst>
                  <a:ext uri="{FF2B5EF4-FFF2-40B4-BE49-F238E27FC236}">
                    <a16:creationId xmlns:a16="http://schemas.microsoft.com/office/drawing/2014/main" id="{B04752FF-27D1-3343-8A4E-1186EB056CDD}"/>
                  </a:ext>
                </a:extLst>
              </p:cNvPr>
              <p:cNvSpPr txBox="1"/>
              <p:nvPr/>
            </p:nvSpPr>
            <p:spPr>
              <a:xfrm>
                <a:off x="8361352" y="6182231"/>
                <a:ext cx="191308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Years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after surgery</a:t>
                </a:r>
                <a:endParaRPr kumimoji="1"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テキスト ボックス 108">
                <a:extLst>
                  <a:ext uri="{FF2B5EF4-FFF2-40B4-BE49-F238E27FC236}">
                    <a16:creationId xmlns:a16="http://schemas.microsoft.com/office/drawing/2014/main" id="{1EAC66AC-FB21-BF42-97F3-EF981B09002A}"/>
                  </a:ext>
                </a:extLst>
              </p:cNvPr>
              <p:cNvSpPr txBox="1"/>
              <p:nvPr/>
            </p:nvSpPr>
            <p:spPr>
              <a:xfrm>
                <a:off x="6333307" y="1591300"/>
                <a:ext cx="745871" cy="4756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 algn="r"/>
                <a:endPara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ja-JP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 algn="r"/>
                <a:endPara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kumimoji="1" lang="en-US" altLang="ja-JP" sz="135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  <a:p>
                <a:pPr algn="r"/>
                <a:endParaRPr kumimoji="1" lang="ja-JP" altLang="en-US" sz="13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正方形/長方形 109">
                <a:extLst>
                  <a:ext uri="{FF2B5EF4-FFF2-40B4-BE49-F238E27FC236}">
                    <a16:creationId xmlns:a16="http://schemas.microsoft.com/office/drawing/2014/main" id="{29A42A2C-E631-874B-ADBE-C7944E7B32B4}"/>
                  </a:ext>
                </a:extLst>
              </p:cNvPr>
              <p:cNvSpPr/>
              <p:nvPr/>
            </p:nvSpPr>
            <p:spPr>
              <a:xfrm>
                <a:off x="9956980" y="5505225"/>
                <a:ext cx="1175712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49</a:t>
                </a:r>
                <a:endParaRPr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正方形/長方形 110">
                <a:extLst>
                  <a:ext uri="{FF2B5EF4-FFF2-40B4-BE49-F238E27FC236}">
                    <a16:creationId xmlns:a16="http://schemas.microsoft.com/office/drawing/2014/main" id="{E9E84B53-B8BC-9440-8927-C23747C679B2}"/>
                  </a:ext>
                </a:extLst>
              </p:cNvPr>
              <p:cNvSpPr/>
              <p:nvPr/>
            </p:nvSpPr>
            <p:spPr>
              <a:xfrm>
                <a:off x="8759662" y="1687277"/>
                <a:ext cx="2299235" cy="68849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6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N</a:t>
                </a:r>
                <a:r>
                  <a:rPr lang="en-US" altLang="ja-JP" sz="16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(abdominal or mediastinal alone)</a:t>
                </a:r>
                <a:endParaRPr lang="ja-JP" altLang="en-US" sz="16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正方形/長方形 111">
                <a:extLst>
                  <a:ext uri="{FF2B5EF4-FFF2-40B4-BE49-F238E27FC236}">
                    <a16:creationId xmlns:a16="http://schemas.microsoft.com/office/drawing/2014/main" id="{47166FDD-5E67-A94B-B185-D67A07399CE2}"/>
                  </a:ext>
                </a:extLst>
              </p:cNvPr>
              <p:cNvSpPr/>
              <p:nvPr/>
            </p:nvSpPr>
            <p:spPr>
              <a:xfrm>
                <a:off x="7945699" y="3876398"/>
                <a:ext cx="2299235" cy="68849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600" dirty="0" err="1">
                    <a:solidFill>
                      <a:schemeClr val="accent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N</a:t>
                </a:r>
                <a:r>
                  <a:rPr lang="en-US" altLang="ja-JP" sz="1600" dirty="0">
                    <a:solidFill>
                      <a:schemeClr val="accent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(abdominal + mediastinal)</a:t>
                </a:r>
                <a:endParaRPr lang="ja-JP" altLang="en-US" sz="1600" dirty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DD1781F7-D8FA-174F-9CEB-252C95376C2B}"/>
                </a:ext>
              </a:extLst>
            </p:cNvPr>
            <p:cNvSpPr txBox="1"/>
            <p:nvPr/>
          </p:nvSpPr>
          <p:spPr>
            <a:xfrm>
              <a:off x="3471822" y="5002537"/>
              <a:ext cx="5073823" cy="3533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               1                2                  3                 4</a:t>
              </a:r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EC5D39D2-E237-CA46-A748-F7504EBA0FF8}"/>
              </a:ext>
            </a:extLst>
          </p:cNvPr>
          <p:cNvSpPr txBox="1"/>
          <p:nvPr/>
        </p:nvSpPr>
        <p:spPr>
          <a:xfrm>
            <a:off x="111649" y="6392256"/>
            <a:ext cx="31133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Disease-free Survival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1E317346-6F0A-5C4E-91D6-462619DBD86F}"/>
              </a:ext>
            </a:extLst>
          </p:cNvPr>
          <p:cNvGrpSpPr/>
          <p:nvPr/>
        </p:nvGrpSpPr>
        <p:grpSpPr>
          <a:xfrm>
            <a:off x="7492840" y="390602"/>
            <a:ext cx="4901345" cy="4205398"/>
            <a:chOff x="7492840" y="390602"/>
            <a:chExt cx="4901345" cy="4205398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0D8C7C08-7AE3-7848-9CC4-954DB1712A0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8163535" y="491339"/>
              <a:ext cx="3601740" cy="4104661"/>
              <a:chOff x="9726389" y="739064"/>
              <a:chExt cx="4242330" cy="4834699"/>
            </a:xfrm>
          </p:grpSpPr>
          <p:pic>
            <p:nvPicPr>
              <p:cNvPr id="93" name="図 92">
                <a:extLst>
                  <a:ext uri="{FF2B5EF4-FFF2-40B4-BE49-F238E27FC236}">
                    <a16:creationId xmlns:a16="http://schemas.microsoft.com/office/drawing/2014/main" id="{05349129-BACD-A947-B27A-481C2E42C9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1464" t="1625" r="4290" b="14536"/>
              <a:stretch/>
            </p:blipFill>
            <p:spPr>
              <a:xfrm>
                <a:off x="9735496" y="739064"/>
                <a:ext cx="4174945" cy="4250169"/>
              </a:xfrm>
              <a:prstGeom prst="rect">
                <a:avLst/>
              </a:prstGeom>
            </p:spPr>
          </p:pic>
          <p:grpSp>
            <p:nvGrpSpPr>
              <p:cNvPr id="96" name="グループ化 95">
                <a:extLst>
                  <a:ext uri="{FF2B5EF4-FFF2-40B4-BE49-F238E27FC236}">
                    <a16:creationId xmlns:a16="http://schemas.microsoft.com/office/drawing/2014/main" id="{C87C403A-A4B2-7B4F-91B4-D77203DCD0CA}"/>
                  </a:ext>
                </a:extLst>
              </p:cNvPr>
              <p:cNvGrpSpPr/>
              <p:nvPr/>
            </p:nvGrpSpPr>
            <p:grpSpPr>
              <a:xfrm>
                <a:off x="9726389" y="905758"/>
                <a:ext cx="4242330" cy="4668005"/>
                <a:chOff x="1395091" y="1852781"/>
                <a:chExt cx="4242330" cy="4668005"/>
              </a:xfrm>
            </p:grpSpPr>
            <p:sp>
              <p:nvSpPr>
                <p:cNvPr id="102" name="テキスト ボックス 101">
                  <a:extLst>
                    <a:ext uri="{FF2B5EF4-FFF2-40B4-BE49-F238E27FC236}">
                      <a16:creationId xmlns:a16="http://schemas.microsoft.com/office/drawing/2014/main" id="{76B14966-6BE9-D047-8BBD-564670180636}"/>
                    </a:ext>
                  </a:extLst>
                </p:cNvPr>
                <p:cNvSpPr txBox="1"/>
                <p:nvPr/>
              </p:nvSpPr>
              <p:spPr>
                <a:xfrm>
                  <a:off x="2721703" y="6182233"/>
                  <a:ext cx="1913088" cy="3385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ears</a:t>
                  </a:r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after surgery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" name="正方形/長方形 98">
                  <a:extLst>
                    <a:ext uri="{FF2B5EF4-FFF2-40B4-BE49-F238E27FC236}">
                      <a16:creationId xmlns:a16="http://schemas.microsoft.com/office/drawing/2014/main" id="{D337959C-E2D9-D749-B541-8D844EB1FBA5}"/>
                    </a:ext>
                  </a:extLst>
                </p:cNvPr>
                <p:cNvSpPr/>
                <p:nvPr/>
              </p:nvSpPr>
              <p:spPr>
                <a:xfrm>
                  <a:off x="4461709" y="5453471"/>
                  <a:ext cx="1175712" cy="33855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98</a:t>
                  </a:r>
                  <a:endParaRPr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正方形/長方形 99">
                  <a:extLst>
                    <a:ext uri="{FF2B5EF4-FFF2-40B4-BE49-F238E27FC236}">
                      <a16:creationId xmlns:a16="http://schemas.microsoft.com/office/drawing/2014/main" id="{EABE303C-953D-EB44-AB84-A8B4374FB526}"/>
                    </a:ext>
                  </a:extLst>
                </p:cNvPr>
                <p:cNvSpPr/>
                <p:nvPr/>
              </p:nvSpPr>
              <p:spPr>
                <a:xfrm>
                  <a:off x="2494148" y="2679738"/>
                  <a:ext cx="2741180" cy="696988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600" dirty="0" err="1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N</a:t>
                  </a:r>
                  <a:r>
                    <a:rPr lang="en-US" altLang="ja-JP" sz="1600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 (abdominal or mediastinal alone)</a:t>
                  </a:r>
                  <a:endParaRPr lang="ja-JP" altLang="en-US" sz="16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正方形/長方形 100">
                  <a:extLst>
                    <a:ext uri="{FF2B5EF4-FFF2-40B4-BE49-F238E27FC236}">
                      <a16:creationId xmlns:a16="http://schemas.microsoft.com/office/drawing/2014/main" id="{3270D444-F282-2242-806C-F8632C84BF20}"/>
                    </a:ext>
                  </a:extLst>
                </p:cNvPr>
                <p:cNvSpPr/>
                <p:nvPr/>
              </p:nvSpPr>
              <p:spPr>
                <a:xfrm>
                  <a:off x="1395091" y="1852781"/>
                  <a:ext cx="2147564" cy="584775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600" dirty="0" err="1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N</a:t>
                  </a:r>
                  <a:r>
                    <a:rPr lang="en-US" altLang="ja-JP" sz="1600" dirty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 (abdominal + mediastinal)</a:t>
                  </a:r>
                  <a:endParaRPr lang="ja-JP" altLang="en-US" sz="1600" dirty="0">
                    <a:solidFill>
                      <a:schemeClr val="accent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8CE57E61-FFAD-B741-B489-8E49E0A24D96}"/>
                </a:ext>
              </a:extLst>
            </p:cNvPr>
            <p:cNvSpPr txBox="1"/>
            <p:nvPr/>
          </p:nvSpPr>
          <p:spPr>
            <a:xfrm>
              <a:off x="7492840" y="390602"/>
              <a:ext cx="633507" cy="4039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  <a:p>
              <a:pPr algn="r"/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FC8785FE-7D6A-114D-86AE-38F62FDF4EBA}"/>
                </a:ext>
              </a:extLst>
            </p:cNvPr>
            <p:cNvSpPr txBox="1"/>
            <p:nvPr/>
          </p:nvSpPr>
          <p:spPr>
            <a:xfrm>
              <a:off x="8084721" y="4058915"/>
              <a:ext cx="430946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               1                2                  3                 4</a:t>
              </a:r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680E42D4-AFD2-6647-87E9-4A02F4DF9D38}"/>
              </a:ext>
            </a:extLst>
          </p:cNvPr>
          <p:cNvGrpSpPr/>
          <p:nvPr/>
        </p:nvGrpSpPr>
        <p:grpSpPr>
          <a:xfrm>
            <a:off x="3174437" y="4763388"/>
            <a:ext cx="4901345" cy="4164798"/>
            <a:chOff x="3158939" y="4933866"/>
            <a:chExt cx="4901345" cy="4164798"/>
          </a:xfrm>
        </p:grpSpPr>
        <p:grpSp>
          <p:nvGrpSpPr>
            <p:cNvPr id="123" name="グループ化 122">
              <a:extLst>
                <a:ext uri="{FF2B5EF4-FFF2-40B4-BE49-F238E27FC236}">
                  <a16:creationId xmlns:a16="http://schemas.microsoft.com/office/drawing/2014/main" id="{331F010A-CEDF-3449-A062-7CF0BB21944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883288" y="4997260"/>
              <a:ext cx="3786962" cy="4101404"/>
              <a:chOff x="3574598" y="6380430"/>
              <a:chExt cx="4480656" cy="4852697"/>
            </a:xfrm>
          </p:grpSpPr>
          <p:pic>
            <p:nvPicPr>
              <p:cNvPr id="124" name="図 123">
                <a:extLst>
                  <a:ext uri="{FF2B5EF4-FFF2-40B4-BE49-F238E27FC236}">
                    <a16:creationId xmlns:a16="http://schemas.microsoft.com/office/drawing/2014/main" id="{B8997C2D-8D09-CD49-BD29-5BBFF89515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1439" t="1832" r="4261" b="15018"/>
              <a:stretch/>
            </p:blipFill>
            <p:spPr>
              <a:xfrm>
                <a:off x="3574598" y="6380430"/>
                <a:ext cx="4213091" cy="4250708"/>
              </a:xfrm>
              <a:prstGeom prst="rect">
                <a:avLst/>
              </a:prstGeom>
            </p:spPr>
          </p:pic>
          <p:grpSp>
            <p:nvGrpSpPr>
              <p:cNvPr id="125" name="グループ化 124">
                <a:extLst>
                  <a:ext uri="{FF2B5EF4-FFF2-40B4-BE49-F238E27FC236}">
                    <a16:creationId xmlns:a16="http://schemas.microsoft.com/office/drawing/2014/main" id="{5BE17BFC-39E6-6243-B88F-DF8E6E1C3018}"/>
                  </a:ext>
                </a:extLst>
              </p:cNvPr>
              <p:cNvGrpSpPr/>
              <p:nvPr/>
            </p:nvGrpSpPr>
            <p:grpSpPr>
              <a:xfrm>
                <a:off x="4467107" y="6531899"/>
                <a:ext cx="3588147" cy="4701228"/>
                <a:chOff x="7952260" y="1819557"/>
                <a:chExt cx="3588147" cy="4701228"/>
              </a:xfrm>
            </p:grpSpPr>
            <p:sp>
              <p:nvSpPr>
                <p:cNvPr id="127" name="テキスト ボックス 126">
                  <a:extLst>
                    <a:ext uri="{FF2B5EF4-FFF2-40B4-BE49-F238E27FC236}">
                      <a16:creationId xmlns:a16="http://schemas.microsoft.com/office/drawing/2014/main" id="{C7F7F54B-8FC6-E84A-AC91-2FF80E825F62}"/>
                    </a:ext>
                  </a:extLst>
                </p:cNvPr>
                <p:cNvSpPr txBox="1"/>
                <p:nvPr/>
              </p:nvSpPr>
              <p:spPr>
                <a:xfrm>
                  <a:off x="8361352" y="6182231"/>
                  <a:ext cx="191308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ears</a:t>
                  </a:r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after surgery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正方形/長方形 128">
                  <a:extLst>
                    <a:ext uri="{FF2B5EF4-FFF2-40B4-BE49-F238E27FC236}">
                      <a16:creationId xmlns:a16="http://schemas.microsoft.com/office/drawing/2014/main" id="{8497452D-0BDD-F042-8080-3F5C600777D6}"/>
                    </a:ext>
                  </a:extLst>
                </p:cNvPr>
                <p:cNvSpPr/>
                <p:nvPr/>
              </p:nvSpPr>
              <p:spPr>
                <a:xfrm>
                  <a:off x="9967803" y="5496252"/>
                  <a:ext cx="1355642" cy="40057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004</a:t>
                  </a:r>
                  <a:endParaRPr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正方形/長方形 129">
                  <a:extLst>
                    <a:ext uri="{FF2B5EF4-FFF2-40B4-BE49-F238E27FC236}">
                      <a16:creationId xmlns:a16="http://schemas.microsoft.com/office/drawing/2014/main" id="{1963A78B-4250-8749-A3C5-371513053245}"/>
                    </a:ext>
                  </a:extLst>
                </p:cNvPr>
                <p:cNvSpPr/>
                <p:nvPr/>
              </p:nvSpPr>
              <p:spPr>
                <a:xfrm>
                  <a:off x="7952260" y="1819557"/>
                  <a:ext cx="2259331" cy="69189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600" dirty="0" err="1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N</a:t>
                  </a:r>
                  <a:r>
                    <a:rPr lang="en-US" altLang="ja-JP" sz="1600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 (abdominal or mediastinal alone)</a:t>
                  </a:r>
                </a:p>
              </p:txBody>
            </p:sp>
            <p:sp>
              <p:nvSpPr>
                <p:cNvPr id="131" name="正方形/長方形 130">
                  <a:extLst>
                    <a:ext uri="{FF2B5EF4-FFF2-40B4-BE49-F238E27FC236}">
                      <a16:creationId xmlns:a16="http://schemas.microsoft.com/office/drawing/2014/main" id="{E158607F-55C8-C549-B02A-0E24C6EBE5D3}"/>
                    </a:ext>
                  </a:extLst>
                </p:cNvPr>
                <p:cNvSpPr/>
                <p:nvPr/>
              </p:nvSpPr>
              <p:spPr>
                <a:xfrm>
                  <a:off x="9031813" y="4159639"/>
                  <a:ext cx="2508594" cy="69189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600" dirty="0" err="1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N</a:t>
                  </a:r>
                  <a:r>
                    <a:rPr lang="en-US" altLang="ja-JP" sz="1600" dirty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 (abdominal + mediastinal)</a:t>
                  </a:r>
                  <a:endParaRPr lang="ja-JP" altLang="en-US" sz="1600" dirty="0">
                    <a:solidFill>
                      <a:schemeClr val="accent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4F96D4F1-CB10-5C45-B6BC-70A7D304988E}"/>
                </a:ext>
              </a:extLst>
            </p:cNvPr>
            <p:cNvSpPr txBox="1"/>
            <p:nvPr/>
          </p:nvSpPr>
          <p:spPr>
            <a:xfrm>
              <a:off x="3158939" y="4933866"/>
              <a:ext cx="633507" cy="4039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  <a:p>
              <a:pPr algn="r"/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C7FDC817-F2B0-3D4D-A846-826289AD61DA}"/>
                </a:ext>
              </a:extLst>
            </p:cNvPr>
            <p:cNvSpPr txBox="1"/>
            <p:nvPr/>
          </p:nvSpPr>
          <p:spPr>
            <a:xfrm>
              <a:off x="3750820" y="8602179"/>
              <a:ext cx="430946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               1                2                  3                 4</a:t>
              </a:r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B8B6A4CD-0960-9D43-9A25-DD67C52CA55D}"/>
              </a:ext>
            </a:extLst>
          </p:cNvPr>
          <p:cNvGrpSpPr/>
          <p:nvPr/>
        </p:nvGrpSpPr>
        <p:grpSpPr>
          <a:xfrm>
            <a:off x="7492840" y="4716890"/>
            <a:ext cx="4901345" cy="4257452"/>
            <a:chOff x="7492840" y="4980360"/>
            <a:chExt cx="4901345" cy="4257452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794F68EB-ADF5-004F-94C5-FAE0D80DA59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8178447" y="5066781"/>
              <a:ext cx="3632795" cy="4171031"/>
              <a:chOff x="9726388" y="6540677"/>
              <a:chExt cx="4086929" cy="4692450"/>
            </a:xfrm>
          </p:grpSpPr>
          <p:pic>
            <p:nvPicPr>
              <p:cNvPr id="94" name="図 93">
                <a:extLst>
                  <a:ext uri="{FF2B5EF4-FFF2-40B4-BE49-F238E27FC236}">
                    <a16:creationId xmlns:a16="http://schemas.microsoft.com/office/drawing/2014/main" id="{EE53E6F0-564D-3C49-B1D1-C12CBA51541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1503" t="2476" r="3624" b="14474"/>
              <a:stretch/>
            </p:blipFill>
            <p:spPr>
              <a:xfrm>
                <a:off x="9726388" y="6540677"/>
                <a:ext cx="4086929" cy="4086929"/>
              </a:xfrm>
              <a:prstGeom prst="rect">
                <a:avLst/>
              </a:prstGeom>
            </p:spPr>
          </p:pic>
          <p:grpSp>
            <p:nvGrpSpPr>
              <p:cNvPr id="115" name="グループ化 114">
                <a:extLst>
                  <a:ext uri="{FF2B5EF4-FFF2-40B4-BE49-F238E27FC236}">
                    <a16:creationId xmlns:a16="http://schemas.microsoft.com/office/drawing/2014/main" id="{CACA8017-82EC-7E4A-A302-008E05A202F3}"/>
                  </a:ext>
                </a:extLst>
              </p:cNvPr>
              <p:cNvGrpSpPr/>
              <p:nvPr/>
            </p:nvGrpSpPr>
            <p:grpSpPr>
              <a:xfrm>
                <a:off x="10182230" y="7424640"/>
                <a:ext cx="3631087" cy="3808487"/>
                <a:chOff x="1850932" y="2712300"/>
                <a:chExt cx="3631087" cy="3808487"/>
              </a:xfrm>
            </p:grpSpPr>
            <p:sp>
              <p:nvSpPr>
                <p:cNvPr id="121" name="テキスト ボックス 120">
                  <a:extLst>
                    <a:ext uri="{FF2B5EF4-FFF2-40B4-BE49-F238E27FC236}">
                      <a16:creationId xmlns:a16="http://schemas.microsoft.com/office/drawing/2014/main" id="{784A517B-81ED-1746-B80C-F217F95ED85C}"/>
                    </a:ext>
                  </a:extLst>
                </p:cNvPr>
                <p:cNvSpPr txBox="1"/>
                <p:nvPr/>
              </p:nvSpPr>
              <p:spPr>
                <a:xfrm>
                  <a:off x="2721703" y="6182233"/>
                  <a:ext cx="1913089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ears</a:t>
                  </a:r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after surgery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正方形/長方形 117">
                  <a:extLst>
                    <a:ext uri="{FF2B5EF4-FFF2-40B4-BE49-F238E27FC236}">
                      <a16:creationId xmlns:a16="http://schemas.microsoft.com/office/drawing/2014/main" id="{72038EC0-DB2D-C142-8C3C-357DB7AB025A}"/>
                    </a:ext>
                  </a:extLst>
                </p:cNvPr>
                <p:cNvSpPr/>
                <p:nvPr/>
              </p:nvSpPr>
              <p:spPr>
                <a:xfrm>
                  <a:off x="4306307" y="5521939"/>
                  <a:ext cx="1175712" cy="33855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01</a:t>
                  </a:r>
                  <a:endParaRPr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正方形/長方形 118">
                  <a:extLst>
                    <a:ext uri="{FF2B5EF4-FFF2-40B4-BE49-F238E27FC236}">
                      <a16:creationId xmlns:a16="http://schemas.microsoft.com/office/drawing/2014/main" id="{E3498A0F-CA4A-7F49-A06E-84423BDDCD0B}"/>
                    </a:ext>
                  </a:extLst>
                </p:cNvPr>
                <p:cNvSpPr/>
                <p:nvPr/>
              </p:nvSpPr>
              <p:spPr>
                <a:xfrm>
                  <a:off x="2525762" y="2712300"/>
                  <a:ext cx="2629654" cy="657878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600" dirty="0" err="1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N</a:t>
                  </a:r>
                  <a:r>
                    <a:rPr lang="en-US" altLang="ja-JP" sz="1600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 (abdominal or mediastinal alone)</a:t>
                  </a:r>
                  <a:endParaRPr lang="ja-JP" altLang="en-US" sz="16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正方形/長方形 119">
                  <a:extLst>
                    <a:ext uri="{FF2B5EF4-FFF2-40B4-BE49-F238E27FC236}">
                      <a16:creationId xmlns:a16="http://schemas.microsoft.com/office/drawing/2014/main" id="{DC599CBD-B5F8-2F4C-8DA6-A5FBF9FC3246}"/>
                    </a:ext>
                  </a:extLst>
                </p:cNvPr>
                <p:cNvSpPr/>
                <p:nvPr/>
              </p:nvSpPr>
              <p:spPr>
                <a:xfrm>
                  <a:off x="1850932" y="4379202"/>
                  <a:ext cx="3304484" cy="33855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600" dirty="0" err="1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N</a:t>
                  </a:r>
                  <a:r>
                    <a:rPr lang="en-US" altLang="ja-JP" sz="1600" dirty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 (abdominal + mediastinal)</a:t>
                  </a:r>
                  <a:endParaRPr lang="ja-JP" altLang="en-US" sz="1600" dirty="0">
                    <a:solidFill>
                      <a:schemeClr val="accent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8DF3FB55-98F5-2A4E-9886-C406C3A0B74D}"/>
                </a:ext>
              </a:extLst>
            </p:cNvPr>
            <p:cNvSpPr txBox="1"/>
            <p:nvPr/>
          </p:nvSpPr>
          <p:spPr>
            <a:xfrm>
              <a:off x="7492840" y="4980360"/>
              <a:ext cx="633507" cy="4039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altLang="ja-JP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  <a:p>
              <a:pPr algn="r"/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75F6D71C-8B75-6E43-BD17-41EEC593EC64}"/>
                </a:ext>
              </a:extLst>
            </p:cNvPr>
            <p:cNvSpPr txBox="1"/>
            <p:nvPr/>
          </p:nvSpPr>
          <p:spPr>
            <a:xfrm>
              <a:off x="8084721" y="8695167"/>
              <a:ext cx="430946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0               1                2                  3                 4</a:t>
              </a:r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13FF92E4-4BD7-924A-8078-04670767D2B5}"/>
              </a:ext>
            </a:extLst>
          </p:cNvPr>
          <p:cNvSpPr txBox="1"/>
          <p:nvPr/>
        </p:nvSpPr>
        <p:spPr>
          <a:xfrm>
            <a:off x="3993869" y="-7990"/>
            <a:ext cx="307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adenocarcinoma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1B5CD70C-7DA1-444B-9EC7-D38DD93E10BB}"/>
              </a:ext>
            </a:extLst>
          </p:cNvPr>
          <p:cNvSpPr txBox="1"/>
          <p:nvPr/>
        </p:nvSpPr>
        <p:spPr>
          <a:xfrm>
            <a:off x="8407282" y="-11143"/>
            <a:ext cx="307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CC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72422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0A4792C-E493-4348-BEEF-F200CA1B00C5}"/>
              </a:ext>
            </a:extLst>
          </p:cNvPr>
          <p:cNvSpPr txBox="1"/>
          <p:nvPr/>
        </p:nvSpPr>
        <p:spPr>
          <a:xfrm>
            <a:off x="164620" y="193436"/>
            <a:ext cx="2842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b="1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ja-JP" altLang="en-US">
              <a:solidFill>
                <a:srgbClr val="FF0000"/>
              </a:solidFill>
            </a:endParaRPr>
          </a:p>
        </p:txBody>
      </p:sp>
      <p:graphicFrame>
        <p:nvGraphicFramePr>
          <p:cNvPr id="46" name="グラフ 45">
            <a:extLst>
              <a:ext uri="{FF2B5EF4-FFF2-40B4-BE49-F238E27FC236}">
                <a16:creationId xmlns:a16="http://schemas.microsoft.com/office/drawing/2014/main" id="{BE06F8B1-C189-AC41-8D8F-C68EA33DAB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4904612"/>
              </p:ext>
            </p:extLst>
          </p:nvPr>
        </p:nvGraphicFramePr>
        <p:xfrm>
          <a:off x="164620" y="1070769"/>
          <a:ext cx="6096000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7" name="グラフ 46">
            <a:extLst>
              <a:ext uri="{FF2B5EF4-FFF2-40B4-BE49-F238E27FC236}">
                <a16:creationId xmlns:a16="http://schemas.microsoft.com/office/drawing/2014/main" id="{E8A69A7C-AF57-364C-9683-8561154A50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9602943"/>
              </p:ext>
            </p:extLst>
          </p:nvPr>
        </p:nvGraphicFramePr>
        <p:xfrm>
          <a:off x="5889144" y="1070769"/>
          <a:ext cx="6340476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7033341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8537FBA-4A8F-8F4A-95E1-A05D56BA15AB}"/>
              </a:ext>
            </a:extLst>
          </p:cNvPr>
          <p:cNvSpPr txBox="1"/>
          <p:nvPr/>
        </p:nvSpPr>
        <p:spPr>
          <a:xfrm>
            <a:off x="164620" y="193436"/>
            <a:ext cx="46800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r>
              <a:rPr lang="en-US" altLang="ja-JP" sz="1800" b="1" i="0" u="none" strike="noStrike" dirty="0">
                <a:effectLst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. Node Zones</a:t>
            </a:r>
            <a:endParaRPr lang="ja-JP" altLang="en-US"/>
          </a:p>
        </p:txBody>
      </p:sp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E8B19F68-B895-794E-B5F0-00CF3CD4A2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9385839"/>
              </p:ext>
            </p:extLst>
          </p:nvPr>
        </p:nvGraphicFramePr>
        <p:xfrm>
          <a:off x="756745" y="804383"/>
          <a:ext cx="10606195" cy="762388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97724">
                  <a:extLst>
                    <a:ext uri="{9D8B030D-6E8A-4147-A177-3AD203B41FA5}">
                      <a16:colId xmlns:a16="http://schemas.microsoft.com/office/drawing/2014/main" val="951559151"/>
                    </a:ext>
                  </a:extLst>
                </a:gridCol>
                <a:gridCol w="2364828">
                  <a:extLst>
                    <a:ext uri="{9D8B030D-6E8A-4147-A177-3AD203B41FA5}">
                      <a16:colId xmlns:a16="http://schemas.microsoft.com/office/drawing/2014/main" val="2246120731"/>
                    </a:ext>
                  </a:extLst>
                </a:gridCol>
                <a:gridCol w="2175641">
                  <a:extLst>
                    <a:ext uri="{9D8B030D-6E8A-4147-A177-3AD203B41FA5}">
                      <a16:colId xmlns:a16="http://schemas.microsoft.com/office/drawing/2014/main" val="4066701464"/>
                    </a:ext>
                  </a:extLst>
                </a:gridCol>
                <a:gridCol w="2743200">
                  <a:extLst>
                    <a:ext uri="{9D8B030D-6E8A-4147-A177-3AD203B41FA5}">
                      <a16:colId xmlns:a16="http://schemas.microsoft.com/office/drawing/2014/main" val="1215257491"/>
                    </a:ext>
                  </a:extLst>
                </a:gridCol>
                <a:gridCol w="1824802">
                  <a:extLst>
                    <a:ext uri="{9D8B030D-6E8A-4147-A177-3AD203B41FA5}">
                      <a16:colId xmlns:a16="http://schemas.microsoft.com/office/drawing/2014/main" val="2352309784"/>
                    </a:ext>
                  </a:extLst>
                </a:gridCol>
              </a:tblGrid>
              <a:tr h="39254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tation number (JES)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ame of node station (JES)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tation number (AJCC)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12923421"/>
                  </a:ext>
                </a:extLst>
              </a:tr>
              <a:tr h="392540">
                <a:tc rowSpan="8"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bdominal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erigastric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ight cardiac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85480069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eft cardiac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8067952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esser curvature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64540917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eft gastric artery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7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92686710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eliac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ommon hepatic artery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8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75155545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eliac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0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82461670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plenic artery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9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44744392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9, 20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Infradiaphragmatic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34718535"/>
                  </a:ext>
                </a:extLst>
              </a:tr>
              <a:tr h="392540">
                <a:tc rowSpan="9">
                  <a:txBody>
                    <a:bodyPr/>
                    <a:lstStyle/>
                    <a:p>
                      <a:pPr algn="l" fontAlgn="ctr"/>
                      <a:r>
                        <a:rPr lang="en-US" altLang="ja-JP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diastinal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rowSpan="3">
                  <a:txBody>
                    <a:bodyPr/>
                    <a:lstStyle/>
                    <a:p>
                      <a:pPr marL="0" marR="0" lvl="0" indent="0" algn="l" defTabSz="1199967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ower mediastinum</a:t>
                      </a:r>
                      <a:endParaRPr lang="ja-JP" alt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0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ower paraesophageal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L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19249595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1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upradiaphragmatic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73405402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2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osterior mediastinum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2353921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1199967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ddle mediastinum</a:t>
                      </a:r>
                      <a:endParaRPr lang="ja-JP" alt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8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iddle paraesophageal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M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69561292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rowSpan="2">
                  <a:txBody>
                    <a:bodyPr/>
                    <a:lstStyle/>
                    <a:p>
                      <a:pPr marL="0" marR="0" lvl="0" indent="0" algn="l" defTabSz="1199967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ubcarinal</a:t>
                      </a:r>
                      <a:endParaRPr lang="ja-JP" alt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7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ubcarinal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56994558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9R/L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ight/Left main bronchus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R/L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31705440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rowSpan="2">
                  <a:txBody>
                    <a:bodyPr/>
                    <a:lstStyle/>
                    <a:p>
                      <a:pPr marL="0" marR="0" lvl="0" indent="0" algn="l" defTabSz="1199967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ight laryngeal nerve</a:t>
                      </a:r>
                      <a:endParaRPr lang="ja-JP" alt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5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Upper paraesophageal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p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55789217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6recR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ight recurrent nerve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R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50709921"/>
                  </a:ext>
                </a:extLst>
              </a:tr>
              <a:tr h="392540">
                <a:tc vMerge="1">
                  <a:txBody>
                    <a:bodyPr/>
                    <a:lstStyle/>
                    <a:p>
                      <a:pPr algn="l" fontAlgn="ctr"/>
                      <a:endParaRPr lang="ja-JP" sz="18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1199967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eft laryngeal nerve</a:t>
                      </a:r>
                      <a:endParaRPr lang="ja-JP" alt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6recL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eft recurrent nerve 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L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1935939"/>
                  </a:ext>
                </a:extLst>
              </a:tr>
              <a:tr h="392540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bbreviations: JES, Japan Esophageal Society; AJCC, American Joint Committee on Cancer</a:t>
                      </a:r>
                      <a:endParaRPr lang="ja-JP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40452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054763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8537FBA-4A8F-8F4A-95E1-A05D56BA15AB}"/>
              </a:ext>
            </a:extLst>
          </p:cNvPr>
          <p:cNvSpPr txBox="1"/>
          <p:nvPr/>
        </p:nvSpPr>
        <p:spPr>
          <a:xfrm>
            <a:off x="164620" y="193436"/>
            <a:ext cx="58190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2. </a:t>
            </a:r>
            <a:endParaRPr lang="ja-JP" altLang="en-US">
              <a:solidFill>
                <a:srgbClr val="FF0000"/>
              </a:solidFill>
            </a:endParaRPr>
          </a:p>
        </p:txBody>
      </p:sp>
      <p:graphicFrame>
        <p:nvGraphicFramePr>
          <p:cNvPr id="5" name="表 5">
            <a:extLst>
              <a:ext uri="{FF2B5EF4-FFF2-40B4-BE49-F238E27FC236}">
                <a16:creationId xmlns:a16="http://schemas.microsoft.com/office/drawing/2014/main" id="{A157E11D-68BD-AE4C-B548-4471592175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5288191"/>
              </p:ext>
            </p:extLst>
          </p:nvPr>
        </p:nvGraphicFramePr>
        <p:xfrm>
          <a:off x="375642" y="1544369"/>
          <a:ext cx="11848704" cy="500516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62176">
                  <a:extLst>
                    <a:ext uri="{9D8B030D-6E8A-4147-A177-3AD203B41FA5}">
                      <a16:colId xmlns:a16="http://schemas.microsoft.com/office/drawing/2014/main" val="2218858037"/>
                    </a:ext>
                  </a:extLst>
                </a:gridCol>
                <a:gridCol w="2962176">
                  <a:extLst>
                    <a:ext uri="{9D8B030D-6E8A-4147-A177-3AD203B41FA5}">
                      <a16:colId xmlns:a16="http://schemas.microsoft.com/office/drawing/2014/main" val="1997646298"/>
                    </a:ext>
                  </a:extLst>
                </a:gridCol>
                <a:gridCol w="2962176">
                  <a:extLst>
                    <a:ext uri="{9D8B030D-6E8A-4147-A177-3AD203B41FA5}">
                      <a16:colId xmlns:a16="http://schemas.microsoft.com/office/drawing/2014/main" val="4272139763"/>
                    </a:ext>
                  </a:extLst>
                </a:gridCol>
                <a:gridCol w="2962176">
                  <a:extLst>
                    <a:ext uri="{9D8B030D-6E8A-4147-A177-3AD203B41FA5}">
                      <a16:colId xmlns:a16="http://schemas.microsoft.com/office/drawing/2014/main" val="1173475228"/>
                    </a:ext>
                  </a:extLst>
                </a:gridCol>
              </a:tblGrid>
              <a:tr h="60811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upper or middle mediastinum LN metastases</a:t>
                      </a: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12588471"/>
                  </a:ext>
                </a:extLst>
              </a:tr>
              <a:tr h="74837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ositive</a:t>
                      </a:r>
                      <a:br>
                        <a:rPr lang="en-US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</a:br>
                      <a:r>
                        <a:rPr lang="en-US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(n=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egative</a:t>
                      </a:r>
                      <a:br>
                        <a:rPr 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</a:br>
                      <a:r>
                        <a:rPr 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(n=33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value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77097806"/>
                  </a:ext>
                </a:extLst>
              </a:tr>
              <a:tr h="6081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Esophageal invasion ≥ 2cm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 (40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0 (63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91130309"/>
                  </a:ext>
                </a:extLst>
              </a:tr>
              <a:tr h="6081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Histology, SC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 (20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 (30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20274567"/>
                  </a:ext>
                </a:extLst>
              </a:tr>
              <a:tr h="6081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T</a:t>
                      </a:r>
                      <a:r>
                        <a:rPr lang="en-US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category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17708270"/>
                  </a:ext>
                </a:extLst>
              </a:tr>
              <a:tr h="6081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cT1-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 (40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 (33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5706217"/>
                  </a:ext>
                </a:extLst>
              </a:tr>
              <a:tr h="6081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cT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 (20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9 (58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62267158"/>
                  </a:ext>
                </a:extLst>
              </a:tr>
              <a:tr h="6081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cT4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 (40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 (9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446096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327108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2">
            <a:extLst>
              <a:ext uri="{FF2B5EF4-FFF2-40B4-BE49-F238E27FC236}">
                <a16:creationId xmlns:a16="http://schemas.microsoft.com/office/drawing/2014/main" id="{F1878BBB-63AE-864D-871C-2EE248FB15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9728192"/>
              </p:ext>
            </p:extLst>
          </p:nvPr>
        </p:nvGraphicFramePr>
        <p:xfrm>
          <a:off x="850231" y="1310409"/>
          <a:ext cx="10844463" cy="462516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110557">
                  <a:extLst>
                    <a:ext uri="{9D8B030D-6E8A-4147-A177-3AD203B41FA5}">
                      <a16:colId xmlns:a16="http://schemas.microsoft.com/office/drawing/2014/main" val="3847207842"/>
                    </a:ext>
                  </a:extLst>
                </a:gridCol>
                <a:gridCol w="3733906">
                  <a:extLst>
                    <a:ext uri="{9D8B030D-6E8A-4147-A177-3AD203B41FA5}">
                      <a16:colId xmlns:a16="http://schemas.microsoft.com/office/drawing/2014/main" val="518719804"/>
                    </a:ext>
                  </a:extLst>
                </a:gridCol>
              </a:tblGrid>
              <a:tr h="37562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o. of patients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44485773"/>
                  </a:ext>
                </a:extLst>
              </a:tr>
              <a:tr h="3756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Locoregional alone (upper mediastinal LN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 (2.6)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14707045"/>
                  </a:ext>
                </a:extLst>
              </a:tr>
              <a:tr h="1244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Locoregional</a:t>
                      </a:r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+ Distant</a:t>
                      </a:r>
                    </a:p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</a:t>
                      </a:r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per mediastinal LN + Pleural</a:t>
                      </a:r>
                    </a:p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pper mediastinal LN + Lung</a:t>
                      </a:r>
                    </a:p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pper mediastinal LN + PALN</a:t>
                      </a:r>
                      <a:endParaRPr lang="en-US" sz="2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 (7.9)</a:t>
                      </a:r>
                    </a:p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 (2.6)</a:t>
                      </a:r>
                    </a:p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 (2.6)</a:t>
                      </a:r>
                    </a:p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 (2.6)</a:t>
                      </a:r>
                      <a:endParaRPr lang="en-US" altLang="ja-JP" sz="2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70694315"/>
                  </a:ext>
                </a:extLst>
              </a:tr>
              <a:tr h="375622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Distant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 (31.6)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82115734"/>
                  </a:ext>
                </a:extLst>
              </a:tr>
              <a:tr h="375622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 Live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6 (15.8)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24130366"/>
                  </a:ext>
                </a:extLst>
              </a:tr>
              <a:tr h="375622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 Lu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 (7.9)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2494415"/>
                  </a:ext>
                </a:extLst>
              </a:tr>
              <a:tr h="3756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 PAL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 (7.9)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49685775"/>
                  </a:ext>
                </a:extLst>
              </a:tr>
              <a:tr h="3756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 Peritoneal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 (7.9)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24979624"/>
                  </a:ext>
                </a:extLst>
              </a:tr>
              <a:tr h="3756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 Pleural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 (2.6)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20348184"/>
                  </a:ext>
                </a:extLst>
              </a:tr>
              <a:tr h="375622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Abbreviations: PALN, Paraaortic lymph nodes </a:t>
                      </a: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8139159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8537FBA-4A8F-8F4A-95E1-A05D56BA15AB}"/>
              </a:ext>
            </a:extLst>
          </p:cNvPr>
          <p:cNvSpPr txBox="1"/>
          <p:nvPr/>
        </p:nvSpPr>
        <p:spPr>
          <a:xfrm>
            <a:off x="164620" y="193436"/>
            <a:ext cx="58190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latin typeface="Arial" panose="020B0604020202020204" pitchFamily="34" charset="0"/>
                <a:cs typeface="Arial" panose="020B0604020202020204" pitchFamily="34" charset="0"/>
              </a:rPr>
              <a:t>Supplementary Table 3. Recurrence pattern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57271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</TotalTime>
  <Words>641</Words>
  <Application>Microsoft Macintosh PowerPoint</Application>
  <PresentationFormat>ユーザー設定</PresentationFormat>
  <Paragraphs>335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菅原 弘太郎</dc:creator>
  <cp:lastModifiedBy>弘太郎 菅原</cp:lastModifiedBy>
  <cp:revision>23</cp:revision>
  <dcterms:created xsi:type="dcterms:W3CDTF">2023-11-29T04:30:23Z</dcterms:created>
  <dcterms:modified xsi:type="dcterms:W3CDTF">2026-03-30T03:35:32Z</dcterms:modified>
</cp:coreProperties>
</file>